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7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1C1C1"/>
    <a:srgbClr val="AAAAAA"/>
    <a:srgbClr val="929292"/>
    <a:srgbClr val="797979"/>
    <a:srgbClr val="5E5E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18"/>
    <p:restoredTop sz="95801"/>
  </p:normalViewPr>
  <p:slideViewPr>
    <p:cSldViewPr snapToGrid="0" snapToObjects="1">
      <p:cViewPr>
        <p:scale>
          <a:sx n="177" d="100"/>
          <a:sy n="177" d="100"/>
        </p:scale>
        <p:origin x="128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FB2EC5-6D58-6D43-A07D-CCC8360DD53F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B563BD-6C94-FD44-AA05-FE5D3CDB5C34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4764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1pPr>
    <a:lvl2pPr marL="503834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2pPr>
    <a:lvl3pPr marL="1007669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3pPr>
    <a:lvl4pPr marL="1511503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4pPr>
    <a:lvl5pPr marL="2015338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5pPr>
    <a:lvl6pPr marL="2519172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6pPr>
    <a:lvl7pPr marL="3023006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7pPr>
    <a:lvl8pPr marL="3526841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8pPr>
    <a:lvl9pPr marL="4030675" algn="l" defTabSz="1007669" rtl="0" eaLnBrk="1" latinLnBrk="0" hangingPunct="1">
      <a:defRPr sz="132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563BD-6C94-FD44-AA05-FE5D3CDB5C34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7602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3126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6628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0168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2874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839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8876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8362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2174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8376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6546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 dirty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63904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B6DCE-ABF9-9E43-BEC1-1E1D97E144AA}" type="datetimeFigureOut">
              <a:rPr lang="en-US" smtClean="0"/>
              <a:t>7/4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2DE69-D5F3-5445-A37C-4CF95E6AA87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6820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E7E6A23-55D5-2241-ACF3-01A3637EE57B}"/>
              </a:ext>
            </a:extLst>
          </p:cNvPr>
          <p:cNvGrpSpPr/>
          <p:nvPr/>
        </p:nvGrpSpPr>
        <p:grpSpPr>
          <a:xfrm>
            <a:off x="56436" y="543245"/>
            <a:ext cx="1073196" cy="1558663"/>
            <a:chOff x="79024" y="800"/>
            <a:chExt cx="1687710" cy="2411015"/>
          </a:xfrm>
          <a:solidFill>
            <a:schemeClr val="bg1"/>
          </a:solidFill>
        </p:grpSpPr>
        <p:sp>
          <p:nvSpPr>
            <p:cNvPr id="5" name="Chevron 4">
              <a:extLst>
                <a:ext uri="{FF2B5EF4-FFF2-40B4-BE49-F238E27FC236}">
                  <a16:creationId xmlns:a16="http://schemas.microsoft.com/office/drawing/2014/main" id="{E9B5B2BA-2D94-6941-85DC-C92E5ED0A2C6}"/>
                </a:ext>
              </a:extLst>
            </p:cNvPr>
            <p:cNvSpPr/>
            <p:nvPr/>
          </p:nvSpPr>
          <p:spPr>
            <a:xfrm rot="5400000">
              <a:off x="-282629" y="362453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6" name="Chevron 4">
              <a:extLst>
                <a:ext uri="{FF2B5EF4-FFF2-40B4-BE49-F238E27FC236}">
                  <a16:creationId xmlns:a16="http://schemas.microsoft.com/office/drawing/2014/main" id="{E74E94F3-0D47-A14D-B3A4-FEF355CB2CFB}"/>
                </a:ext>
              </a:extLst>
            </p:cNvPr>
            <p:cNvSpPr txBox="1"/>
            <p:nvPr/>
          </p:nvSpPr>
          <p:spPr>
            <a:xfrm>
              <a:off x="124179" y="889811"/>
              <a:ext cx="1608688" cy="723305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Pre-planning basics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6179A330-4313-BE49-94FE-EA27A87832A1}"/>
              </a:ext>
            </a:extLst>
          </p:cNvPr>
          <p:cNvGrpSpPr/>
          <p:nvPr/>
        </p:nvGrpSpPr>
        <p:grpSpPr>
          <a:xfrm>
            <a:off x="35552" y="3000371"/>
            <a:ext cx="1081547" cy="1558663"/>
            <a:chOff x="1" y="2223491"/>
            <a:chExt cx="1687710" cy="2411015"/>
          </a:xfrm>
          <a:solidFill>
            <a:schemeClr val="bg1">
              <a:lumMod val="85000"/>
            </a:schemeClr>
          </a:solidFill>
        </p:grpSpPr>
        <p:sp>
          <p:nvSpPr>
            <p:cNvPr id="8" name="Chevron 7">
              <a:extLst>
                <a:ext uri="{FF2B5EF4-FFF2-40B4-BE49-F238E27FC236}">
                  <a16:creationId xmlns:a16="http://schemas.microsoft.com/office/drawing/2014/main" id="{E4E9ACC1-F9C1-AF41-9158-0A75F303DB25}"/>
                </a:ext>
              </a:extLst>
            </p:cNvPr>
            <p:cNvSpPr/>
            <p:nvPr/>
          </p:nvSpPr>
          <p:spPr>
            <a:xfrm rot="5400000">
              <a:off x="-361652" y="2585144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9" name="Chevron 4">
              <a:extLst>
                <a:ext uri="{FF2B5EF4-FFF2-40B4-BE49-F238E27FC236}">
                  <a16:creationId xmlns:a16="http://schemas.microsoft.com/office/drawing/2014/main" id="{187A57A6-72EB-474C-A655-CC82AC8FBBF5}"/>
                </a:ext>
              </a:extLst>
            </p:cNvPr>
            <p:cNvSpPr txBox="1"/>
            <p:nvPr/>
          </p:nvSpPr>
          <p:spPr>
            <a:xfrm>
              <a:off x="67731" y="3146369"/>
              <a:ext cx="1563541" cy="723305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Curriculum to be evaluated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E2B45D9A-BD2F-8143-A0EB-FC070B87F90C}"/>
              </a:ext>
            </a:extLst>
          </p:cNvPr>
          <p:cNvGrpSpPr/>
          <p:nvPr/>
        </p:nvGrpSpPr>
        <p:grpSpPr>
          <a:xfrm>
            <a:off x="56445" y="1796301"/>
            <a:ext cx="1060655" cy="1558663"/>
            <a:chOff x="1" y="4446182"/>
            <a:chExt cx="1687710" cy="2411015"/>
          </a:xfrm>
          <a:solidFill>
            <a:schemeClr val="bg1">
              <a:lumMod val="95000"/>
            </a:schemeClr>
          </a:solidFill>
        </p:grpSpPr>
        <p:sp>
          <p:nvSpPr>
            <p:cNvPr id="11" name="Chevron 10">
              <a:extLst>
                <a:ext uri="{FF2B5EF4-FFF2-40B4-BE49-F238E27FC236}">
                  <a16:creationId xmlns:a16="http://schemas.microsoft.com/office/drawing/2014/main" id="{6EEB1B38-B178-0344-98C8-321769DF618E}"/>
                </a:ext>
              </a:extLst>
            </p:cNvPr>
            <p:cNvSpPr/>
            <p:nvPr/>
          </p:nvSpPr>
          <p:spPr>
            <a:xfrm rot="5400000">
              <a:off x="-361652" y="4807835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2" name="Chevron 4">
              <a:extLst>
                <a:ext uri="{FF2B5EF4-FFF2-40B4-BE49-F238E27FC236}">
                  <a16:creationId xmlns:a16="http://schemas.microsoft.com/office/drawing/2014/main" id="{20AEA024-9A6C-8E4A-B957-5F2C47947782}"/>
                </a:ext>
              </a:extLst>
            </p:cNvPr>
            <p:cNvSpPr txBox="1"/>
            <p:nvPr/>
          </p:nvSpPr>
          <p:spPr>
            <a:xfrm>
              <a:off x="35820" y="5318326"/>
              <a:ext cx="1651891" cy="723305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Curriculum for comparison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0B23543-369A-EB4C-9481-A64E0EF333A9}"/>
              </a:ext>
            </a:extLst>
          </p:cNvPr>
          <p:cNvGrpSpPr/>
          <p:nvPr/>
        </p:nvGrpSpPr>
        <p:grpSpPr>
          <a:xfrm>
            <a:off x="35552" y="4207843"/>
            <a:ext cx="1081547" cy="1558665"/>
            <a:chOff x="79024" y="800"/>
            <a:chExt cx="1687710" cy="2411015"/>
          </a:xfrm>
          <a:solidFill>
            <a:srgbClr val="C1C1C1"/>
          </a:solidFill>
        </p:grpSpPr>
        <p:sp>
          <p:nvSpPr>
            <p:cNvPr id="14" name="Chevron 13">
              <a:extLst>
                <a:ext uri="{FF2B5EF4-FFF2-40B4-BE49-F238E27FC236}">
                  <a16:creationId xmlns:a16="http://schemas.microsoft.com/office/drawing/2014/main" id="{C9D28F1D-B2FA-A846-9C37-E8F494E67FE4}"/>
                </a:ext>
              </a:extLst>
            </p:cNvPr>
            <p:cNvSpPr/>
            <p:nvPr/>
          </p:nvSpPr>
          <p:spPr>
            <a:xfrm rot="5400000">
              <a:off x="-282629" y="362453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5" name="Chevron 4">
              <a:extLst>
                <a:ext uri="{FF2B5EF4-FFF2-40B4-BE49-F238E27FC236}">
                  <a16:creationId xmlns:a16="http://schemas.microsoft.com/office/drawing/2014/main" id="{553E3CF9-C2BF-AC4A-ADCD-558C2EEE3C03}"/>
                </a:ext>
              </a:extLst>
            </p:cNvPr>
            <p:cNvSpPr txBox="1"/>
            <p:nvPr/>
          </p:nvSpPr>
          <p:spPr>
            <a:xfrm>
              <a:off x="124179" y="895173"/>
              <a:ext cx="1608688" cy="723305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Spreadsheet set-up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42A4FD0-EF24-3D4F-B48B-664977A17477}"/>
              </a:ext>
            </a:extLst>
          </p:cNvPr>
          <p:cNvGrpSpPr/>
          <p:nvPr/>
        </p:nvGrpSpPr>
        <p:grpSpPr>
          <a:xfrm>
            <a:off x="84285" y="6579533"/>
            <a:ext cx="1045353" cy="1558664"/>
            <a:chOff x="1" y="2223491"/>
            <a:chExt cx="1687710" cy="2411015"/>
          </a:xfrm>
          <a:solidFill>
            <a:srgbClr val="929292"/>
          </a:solidFill>
        </p:grpSpPr>
        <p:sp>
          <p:nvSpPr>
            <p:cNvPr id="17" name="Chevron 16">
              <a:extLst>
                <a:ext uri="{FF2B5EF4-FFF2-40B4-BE49-F238E27FC236}">
                  <a16:creationId xmlns:a16="http://schemas.microsoft.com/office/drawing/2014/main" id="{C24F1AE1-66B5-364D-945F-FEDCEAD3853D}"/>
                </a:ext>
              </a:extLst>
            </p:cNvPr>
            <p:cNvSpPr/>
            <p:nvPr/>
          </p:nvSpPr>
          <p:spPr>
            <a:xfrm rot="5400000">
              <a:off x="-361652" y="2585144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8" name="Chevron 4">
              <a:extLst>
                <a:ext uri="{FF2B5EF4-FFF2-40B4-BE49-F238E27FC236}">
                  <a16:creationId xmlns:a16="http://schemas.microsoft.com/office/drawing/2014/main" id="{78BBDD11-835A-C647-B202-52744817910F}"/>
                </a:ext>
              </a:extLst>
            </p:cNvPr>
            <p:cNvSpPr txBox="1"/>
            <p:nvPr/>
          </p:nvSpPr>
          <p:spPr>
            <a:xfrm>
              <a:off x="33865" y="3109254"/>
              <a:ext cx="1619070" cy="723306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Data amalgamation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89DC4650-19AE-FE49-BC3C-FAF041057143}"/>
              </a:ext>
            </a:extLst>
          </p:cNvPr>
          <p:cNvGrpSpPr/>
          <p:nvPr/>
        </p:nvGrpSpPr>
        <p:grpSpPr>
          <a:xfrm>
            <a:off x="56437" y="5388372"/>
            <a:ext cx="1074708" cy="1558664"/>
            <a:chOff x="1" y="4446182"/>
            <a:chExt cx="1687710" cy="2411015"/>
          </a:xfrm>
          <a:solidFill>
            <a:srgbClr val="AAAAAA"/>
          </a:solidFill>
        </p:grpSpPr>
        <p:sp>
          <p:nvSpPr>
            <p:cNvPr id="20" name="Chevron 19">
              <a:extLst>
                <a:ext uri="{FF2B5EF4-FFF2-40B4-BE49-F238E27FC236}">
                  <a16:creationId xmlns:a16="http://schemas.microsoft.com/office/drawing/2014/main" id="{653F0FB2-5A61-9642-8E3F-507F73CB36EB}"/>
                </a:ext>
              </a:extLst>
            </p:cNvPr>
            <p:cNvSpPr/>
            <p:nvPr/>
          </p:nvSpPr>
          <p:spPr>
            <a:xfrm rot="5400000">
              <a:off x="-361652" y="4807835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1" name="Chevron 4">
              <a:extLst>
                <a:ext uri="{FF2B5EF4-FFF2-40B4-BE49-F238E27FC236}">
                  <a16:creationId xmlns:a16="http://schemas.microsoft.com/office/drawing/2014/main" id="{D0269A49-7B8E-8E49-AD6F-805B81B2C2D0}"/>
                </a:ext>
              </a:extLst>
            </p:cNvPr>
            <p:cNvSpPr txBox="1"/>
            <p:nvPr/>
          </p:nvSpPr>
          <p:spPr>
            <a:xfrm>
              <a:off x="46100" y="5290037"/>
              <a:ext cx="1586133" cy="723306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Spreadsheet data entry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F42B3CDB-E713-EF4B-8D80-8D700830C10E}"/>
              </a:ext>
            </a:extLst>
          </p:cNvPr>
          <p:cNvGrpSpPr/>
          <p:nvPr/>
        </p:nvGrpSpPr>
        <p:grpSpPr>
          <a:xfrm>
            <a:off x="63959" y="7759547"/>
            <a:ext cx="1074709" cy="1558664"/>
            <a:chOff x="79024" y="800"/>
            <a:chExt cx="1687710" cy="2411015"/>
          </a:xfrm>
          <a:solidFill>
            <a:srgbClr val="797979"/>
          </a:solidFill>
        </p:grpSpPr>
        <p:sp>
          <p:nvSpPr>
            <p:cNvPr id="23" name="Chevron 22">
              <a:extLst>
                <a:ext uri="{FF2B5EF4-FFF2-40B4-BE49-F238E27FC236}">
                  <a16:creationId xmlns:a16="http://schemas.microsoft.com/office/drawing/2014/main" id="{725CAB5C-CC0C-6D4A-A49D-BE08DDD36DE5}"/>
                </a:ext>
              </a:extLst>
            </p:cNvPr>
            <p:cNvSpPr/>
            <p:nvPr/>
          </p:nvSpPr>
          <p:spPr>
            <a:xfrm rot="5400000">
              <a:off x="-282629" y="362453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4" name="Chevron 4">
              <a:extLst>
                <a:ext uri="{FF2B5EF4-FFF2-40B4-BE49-F238E27FC236}">
                  <a16:creationId xmlns:a16="http://schemas.microsoft.com/office/drawing/2014/main" id="{52D153FB-E809-BE47-9B4C-9B256BA5EC40}"/>
                </a:ext>
              </a:extLst>
            </p:cNvPr>
            <p:cNvSpPr txBox="1"/>
            <p:nvPr/>
          </p:nvSpPr>
          <p:spPr>
            <a:xfrm>
              <a:off x="124179" y="867233"/>
              <a:ext cx="1608688" cy="723305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Data presentation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7E09DDC3-E1A0-A34C-8674-351842C2B6AA}"/>
              </a:ext>
            </a:extLst>
          </p:cNvPr>
          <p:cNvGrpSpPr/>
          <p:nvPr/>
        </p:nvGrpSpPr>
        <p:grpSpPr>
          <a:xfrm>
            <a:off x="80090" y="8954998"/>
            <a:ext cx="1074710" cy="1722608"/>
            <a:chOff x="1" y="4446182"/>
            <a:chExt cx="1687710" cy="2411015"/>
          </a:xfrm>
          <a:solidFill>
            <a:srgbClr val="5E5E5E"/>
          </a:solidFill>
        </p:grpSpPr>
        <p:sp>
          <p:nvSpPr>
            <p:cNvPr id="26" name="Chevron 25">
              <a:extLst>
                <a:ext uri="{FF2B5EF4-FFF2-40B4-BE49-F238E27FC236}">
                  <a16:creationId xmlns:a16="http://schemas.microsoft.com/office/drawing/2014/main" id="{F39827A9-3ED5-D242-A158-99A27EED57EF}"/>
                </a:ext>
              </a:extLst>
            </p:cNvPr>
            <p:cNvSpPr/>
            <p:nvPr/>
          </p:nvSpPr>
          <p:spPr>
            <a:xfrm rot="5400000">
              <a:off x="-361652" y="4807835"/>
              <a:ext cx="2411015" cy="1687710"/>
            </a:xfrm>
            <a:prstGeom prst="chevron">
              <a:avLst/>
            </a:prstGeom>
            <a:grpFill/>
          </p:spPr>
          <p:style>
            <a:lnRef idx="2">
              <a:schemeClr val="dk1">
                <a:shade val="80000"/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27" name="Chevron 4">
              <a:extLst>
                <a:ext uri="{FF2B5EF4-FFF2-40B4-BE49-F238E27FC236}">
                  <a16:creationId xmlns:a16="http://schemas.microsoft.com/office/drawing/2014/main" id="{58EC5DC0-1195-C544-B259-4EBD4ACCB749}"/>
                </a:ext>
              </a:extLst>
            </p:cNvPr>
            <p:cNvSpPr txBox="1"/>
            <p:nvPr/>
          </p:nvSpPr>
          <p:spPr>
            <a:xfrm>
              <a:off x="39524" y="5290038"/>
              <a:ext cx="1588981" cy="723305"/>
            </a:xfrm>
            <a:prstGeom prst="rect">
              <a:avLst/>
            </a:prstGeom>
            <a:grp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3970" tIns="13970" rIns="13970" bIns="13970" numCol="1" spcCol="1270" anchor="ctr" anchorCtr="0">
              <a:noAutofit/>
            </a:bodyPr>
            <a:lstStyle/>
            <a:p>
              <a:pPr marL="0" lvl="0" indent="0" algn="ctr" defTabSz="9779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GB" sz="1200" kern="1200" dirty="0"/>
                <a:t>Data validation</a:t>
              </a:r>
            </a:p>
          </p:txBody>
        </p:sp>
      </p:grpSp>
      <p:sp>
        <p:nvSpPr>
          <p:cNvPr id="28" name="Rectangle 27">
            <a:extLst>
              <a:ext uri="{FF2B5EF4-FFF2-40B4-BE49-F238E27FC236}">
                <a16:creationId xmlns:a16="http://schemas.microsoft.com/office/drawing/2014/main" id="{6AF86871-9BE0-3A49-8E83-524785F86D07}"/>
              </a:ext>
            </a:extLst>
          </p:cNvPr>
          <p:cNvSpPr/>
          <p:nvPr/>
        </p:nvSpPr>
        <p:spPr>
          <a:xfrm>
            <a:off x="1154799" y="543245"/>
            <a:ext cx="6320062" cy="104232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AA1142E-B56F-0047-80BE-16067701BD1E}"/>
              </a:ext>
            </a:extLst>
          </p:cNvPr>
          <p:cNvSpPr txBox="1"/>
          <p:nvPr/>
        </p:nvSpPr>
        <p:spPr>
          <a:xfrm>
            <a:off x="1129632" y="612178"/>
            <a:ext cx="6320063" cy="104644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Identify who will undertake the heat mapping exercise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Identify aims of the mapping project e.g. to create a heat map of the pathology curriculum for a particular MBChB degree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Identify timescales and outputs expected from the mapping exercise</a:t>
            </a:r>
          </a:p>
          <a:p>
            <a:endParaRPr lang="en-U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E79D10DE-88AD-1D4A-B425-F98BFF06A3CA}"/>
              </a:ext>
            </a:extLst>
          </p:cNvPr>
          <p:cNvSpPr/>
          <p:nvPr/>
        </p:nvSpPr>
        <p:spPr>
          <a:xfrm>
            <a:off x="1137994" y="1782650"/>
            <a:ext cx="6320062" cy="1042323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A6F9469-EA4F-0040-8AEF-D8973A40609A}"/>
              </a:ext>
            </a:extLst>
          </p:cNvPr>
          <p:cNvSpPr txBox="1"/>
          <p:nvPr/>
        </p:nvSpPr>
        <p:spPr>
          <a:xfrm>
            <a:off x="1117101" y="1800732"/>
            <a:ext cx="6208168" cy="1215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Choose the curriculum you will be examining from your institution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Identify exclusion criteria for sessions to be examined e.g. administrative or pastoral lectures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Decide the method to map the session content e.g., using intended learning outcomes as a proxy for the session content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For each session to be evaluated, decide on the intent of the lectures using the method </a:t>
            </a:r>
          </a:p>
          <a:p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F91DF97C-F2C9-1A43-A303-CE7276AD9559}"/>
              </a:ext>
            </a:extLst>
          </p:cNvPr>
          <p:cNvSpPr/>
          <p:nvPr/>
        </p:nvSpPr>
        <p:spPr>
          <a:xfrm>
            <a:off x="1145470" y="3000371"/>
            <a:ext cx="6320062" cy="1020053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A3D19D9-B455-6244-98EA-444F88841521}"/>
              </a:ext>
            </a:extLst>
          </p:cNvPr>
          <p:cNvSpPr txBox="1"/>
          <p:nvPr/>
        </p:nvSpPr>
        <p:spPr>
          <a:xfrm>
            <a:off x="1108097" y="3013221"/>
            <a:ext cx="6217172" cy="1215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Choose a curriculum/ standard to compare your curriculum to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Decide at what depth to compare the two curricula e.g., comparing intended learning outcomes to the fields level of the comparator curriculum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Understand the content of the level chosen e.g., for the fields column in this exercise, ILOs attached to each field were used as the guide of what the field meant</a:t>
            </a:r>
          </a:p>
          <a:p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66B1662D-0266-E644-9A9E-1AB84298DC35}"/>
              </a:ext>
            </a:extLst>
          </p:cNvPr>
          <p:cNvSpPr/>
          <p:nvPr/>
        </p:nvSpPr>
        <p:spPr>
          <a:xfrm>
            <a:off x="1166515" y="5387936"/>
            <a:ext cx="6299017" cy="1020057"/>
          </a:xfrm>
          <a:prstGeom prst="rect">
            <a:avLst/>
          </a:prstGeom>
          <a:solidFill>
            <a:srgbClr val="AAAAAA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13C4BE23-4E08-EC46-A016-69A18C1338BA}"/>
              </a:ext>
            </a:extLst>
          </p:cNvPr>
          <p:cNvSpPr/>
          <p:nvPr/>
        </p:nvSpPr>
        <p:spPr>
          <a:xfrm>
            <a:off x="1152029" y="6583388"/>
            <a:ext cx="6305817" cy="1036370"/>
          </a:xfrm>
          <a:prstGeom prst="rect">
            <a:avLst/>
          </a:prstGeom>
          <a:solidFill>
            <a:srgbClr val="92929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944D94A0-BE44-0447-9CCA-6C893505668F}"/>
              </a:ext>
            </a:extLst>
          </p:cNvPr>
          <p:cNvSpPr/>
          <p:nvPr/>
        </p:nvSpPr>
        <p:spPr>
          <a:xfrm>
            <a:off x="1152237" y="4195396"/>
            <a:ext cx="6305819" cy="1046440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4A63C3F-D208-864C-AF1F-6F3D26DF7F6D}"/>
              </a:ext>
            </a:extLst>
          </p:cNvPr>
          <p:cNvSpPr txBox="1"/>
          <p:nvPr/>
        </p:nvSpPr>
        <p:spPr>
          <a:xfrm>
            <a:off x="1117099" y="4177583"/>
            <a:ext cx="6305818" cy="110799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Open a new Excel spreadsheet and create new tabs for each component of the course 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Create a new tab for your final comparison e.g. a ‘weeks’ tab (see data amalgamation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For each tab, enter the curriculum comparison areas along the columns 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Enter the session name for each session of your curriculum for evaluation into a separate row providing a grid where each session can be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This should provide a grid where each session can be compared to each column</a:t>
            </a:r>
            <a:endParaRPr lang="en-US" sz="11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4B65F3A-7C67-4049-9447-815878EF37AD}"/>
              </a:ext>
            </a:extLst>
          </p:cNvPr>
          <p:cNvSpPr txBox="1"/>
          <p:nvPr/>
        </p:nvSpPr>
        <p:spPr>
          <a:xfrm>
            <a:off x="1132395" y="6613219"/>
            <a:ext cx="6290522" cy="1215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Decide which level of the course you wish to use for your comparison (e.g. comparing  weeks, years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Create a new line of the spreadsheet at each level (e.g. a new line after each week one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Using the SUM function, add up each column’s values for the level of interest 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Transfer lines which use the SUM function to the final comparison tab e.g., a ‘weeks’ spreadsheet and label each row appropriately depending on what it represents e.g. week 1, week 2 </a:t>
            </a:r>
          </a:p>
          <a:p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7D05431-C0AB-484F-B130-9C20D8113B43}"/>
              </a:ext>
            </a:extLst>
          </p:cNvPr>
          <p:cNvSpPr txBox="1"/>
          <p:nvPr/>
        </p:nvSpPr>
        <p:spPr>
          <a:xfrm>
            <a:off x="1131046" y="5478346"/>
            <a:ext cx="6305818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Take each session’s intent (identified in pre-planning) in turn and compare it to every column’s meaning (also identified in pre-planning) 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If the intent matches the column’s meaning, place a 1 in this box. If not, leave it blank to represent a 0 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Repeat this process for every session in the spreadsheet</a:t>
            </a:r>
          </a:p>
          <a:p>
            <a:endParaRPr lang="en-US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B0A04067-EB56-804D-A121-8AB0804B21C1}"/>
              </a:ext>
            </a:extLst>
          </p:cNvPr>
          <p:cNvSpPr/>
          <p:nvPr/>
        </p:nvSpPr>
        <p:spPr>
          <a:xfrm>
            <a:off x="1179967" y="8954998"/>
            <a:ext cx="6274450" cy="1216665"/>
          </a:xfrm>
          <a:prstGeom prst="rect">
            <a:avLst/>
          </a:prstGeom>
          <a:solidFill>
            <a:srgbClr val="5E5E5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0651868C-C591-9546-BEDE-F1A52F481F59}"/>
              </a:ext>
            </a:extLst>
          </p:cNvPr>
          <p:cNvSpPr/>
          <p:nvPr/>
        </p:nvSpPr>
        <p:spPr>
          <a:xfrm>
            <a:off x="1166514" y="7749355"/>
            <a:ext cx="6290521" cy="1036370"/>
          </a:xfrm>
          <a:prstGeom prst="rect">
            <a:avLst/>
          </a:prstGeom>
          <a:solidFill>
            <a:srgbClr val="797979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507EB1C-6B4C-BE47-BA3C-69D6908E1C52}"/>
              </a:ext>
            </a:extLst>
          </p:cNvPr>
          <p:cNvSpPr txBox="1"/>
          <p:nvPr/>
        </p:nvSpPr>
        <p:spPr>
          <a:xfrm>
            <a:off x="1145470" y="7882707"/>
            <a:ext cx="6179799" cy="7694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Using the final comparison tab, highlight all the cells and use the conditional formatting tool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Follow the instructions to create a scale of colour (a scale of blue was chosen here to avoid issues of colour-blindness)</a:t>
            </a:r>
          </a:p>
          <a:p>
            <a:pPr marL="285750" lvl="0" indent="-285750">
              <a:buFont typeface="Arial" panose="020B0604020202020204" pitchFamily="34" charset="0"/>
              <a:buChar char="•"/>
            </a:pPr>
            <a:r>
              <a:rPr lang="en-GB" sz="1100" dirty="0"/>
              <a:t>This  gives  a completed summary heat map at the level of your choice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5C08884-1715-D34A-BF34-746FA4658846}"/>
              </a:ext>
            </a:extLst>
          </p:cNvPr>
          <p:cNvSpPr txBox="1"/>
          <p:nvPr/>
        </p:nvSpPr>
        <p:spPr>
          <a:xfrm>
            <a:off x="1152030" y="9255280"/>
            <a:ext cx="61732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100" dirty="0"/>
              <a:t>Compare your findings to other documents about your curriculum coverage e.g. previous internal curriculum maps and blueprint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4668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</TotalTime>
  <Words>515</Words>
  <Application>Microsoft Macintosh PowerPoint</Application>
  <PresentationFormat>Custom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ron Sneddon</dc:creator>
  <cp:lastModifiedBy>Sharon Sneddon</cp:lastModifiedBy>
  <cp:revision>10</cp:revision>
  <dcterms:created xsi:type="dcterms:W3CDTF">2020-07-16T13:34:09Z</dcterms:created>
  <dcterms:modified xsi:type="dcterms:W3CDTF">2021-07-04T18:03:00Z</dcterms:modified>
</cp:coreProperties>
</file>